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9148" autoAdjust="0"/>
  </p:normalViewPr>
  <p:slideViewPr>
    <p:cSldViewPr snapToGrid="0">
      <p:cViewPr varScale="1">
        <p:scale>
          <a:sx n="116" d="100"/>
          <a:sy n="116" d="100"/>
        </p:scale>
        <p:origin x="2040" y="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271E74-68C0-B842-8938-5BEA0C462E20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C4186B-D30A-EF49-BF87-826FEA6208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5281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C4186B-D30A-EF49-BF87-826FEA62080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3199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F55E5-906D-44C8-8FBA-ED11280B36AC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ADDB-73FF-4B33-BC10-016B65D4C2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725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F55E5-906D-44C8-8FBA-ED11280B36AC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ADDB-73FF-4B33-BC10-016B65D4C2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65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F55E5-906D-44C8-8FBA-ED11280B36AC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ADDB-73FF-4B33-BC10-016B65D4C2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005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F55E5-906D-44C8-8FBA-ED11280B36AC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ADDB-73FF-4B33-BC10-016B65D4C2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401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F55E5-906D-44C8-8FBA-ED11280B36AC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ADDB-73FF-4B33-BC10-016B65D4C2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5910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F55E5-906D-44C8-8FBA-ED11280B36AC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ADDB-73FF-4B33-BC10-016B65D4C2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751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F55E5-906D-44C8-8FBA-ED11280B36AC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ADDB-73FF-4B33-BC10-016B65D4C2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036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F55E5-906D-44C8-8FBA-ED11280B36AC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ADDB-73FF-4B33-BC10-016B65D4C2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70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F55E5-906D-44C8-8FBA-ED11280B36AC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ADDB-73FF-4B33-BC10-016B65D4C2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71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F55E5-906D-44C8-8FBA-ED11280B36AC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ADDB-73FF-4B33-BC10-016B65D4C2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26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F55E5-906D-44C8-8FBA-ED11280B36AC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ADDB-73FF-4B33-BC10-016B65D4C2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046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4F55E5-906D-44C8-8FBA-ED11280B36AC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6ADDB-73FF-4B33-BC10-016B65D4C2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99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4146" y="5780786"/>
            <a:ext cx="863337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 Phylogenetic analysis of the partial nucleotide sequences of the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rpo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gene of </a:t>
            </a:r>
            <a:r>
              <a:rPr lang="en-US" sz="1100" i="1">
                <a:latin typeface="Arial" panose="020B0604020202020204" pitchFamily="34" charset="0"/>
                <a:cs typeface="Arial" panose="020B0604020202020204" pitchFamily="34" charset="0"/>
              </a:rPr>
              <a:t>Leptospira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 strain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 this study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arley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arble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Dozer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ewis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arney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Darla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oss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iranda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randi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aryAnn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riel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Jupiter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andy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indi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Daisy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race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ank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eeko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ali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olden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andonK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with cognate gene of other leptospiral species (La Scola et al., 2006 [16]).  The tree was generated using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iou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9.0.5.</a:t>
            </a:r>
            <a:endParaRPr lang="en-US" sz="1600" dirty="0">
              <a:latin typeface="Arial"/>
              <a:cs typeface="Arial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ED4FF17-E9B8-4749-8151-96E5BD40F70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480" y="123022"/>
            <a:ext cx="5519450" cy="5519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86737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4</TotalTime>
  <Words>90</Words>
  <Application>Microsoft Macintosh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uszynski, Karen</dc:creator>
  <cp:lastModifiedBy>Microsoft Office User</cp:lastModifiedBy>
  <cp:revision>37</cp:revision>
  <dcterms:created xsi:type="dcterms:W3CDTF">2018-12-14T03:06:10Z</dcterms:created>
  <dcterms:modified xsi:type="dcterms:W3CDTF">2019-12-12T21:52:41Z</dcterms:modified>
</cp:coreProperties>
</file>